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ABC14-CCC0-4F7C-B6DD-A9FCD3A843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24732-CF3A-42DB-8610-3A2E87E318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5D765-B400-4169-A70F-1F9E5F02C7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742D8-EECA-45AC-A596-DEBFB4E9AD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D5CEA-9C6C-48B7-B995-D3345879CB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25301-C133-4810-BF66-5FFD298696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2A124-3D90-44C3-9F66-F1275CEF07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4124C3-A793-414B-824C-9C3F277A9C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B54B7A-8BF8-4379-9953-A61FFE37E9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93DA3-ACF8-4306-9AF6-F9E7EA7609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DA0F6-4CD0-469E-964E-AEEBE12385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CFB05-6F2B-4115-AA57-D1B88F260A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AC7222-8B93-419C-9545-F27A6BF513E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1242720" y="821880"/>
            <a:ext cx="6249240" cy="67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l Tabl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Correlation between HCVrp infectivity and candidate receptor expression in several cell l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295280" y="1716120"/>
          <a:ext cx="6629400" cy="2498760"/>
        </p:xfrm>
        <a:graphic>
          <a:graphicData uri="http://schemas.openxmlformats.org/drawingml/2006/table">
            <a:tbl>
              <a:tblPr/>
              <a:tblGrid>
                <a:gridCol w="928800"/>
                <a:gridCol w="1162080"/>
                <a:gridCol w="2973240"/>
                <a:gridCol w="1565280"/>
              </a:tblGrid>
              <a:tr h="2869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eporter assa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xpressions of candidate recepto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SGP-R 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uh-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D81, SR-BI, claudin-1, occludin </a:t>
                      </a:r>
                      <a:r>
                        <a:rPr b="0" lang="it-IT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7, 88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yes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89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uh-7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++ / +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D81, SR-BI, claudin-1, occlud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ye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sc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++ / ++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D81, SR-BI (others n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93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D81, occludin (no SR-BI or claudin-1) 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yes (HEK-293 cell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eL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±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D81, SR-BI, occludin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(no claudin-1) 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os-CCR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±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W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epG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R-BI, claudin-1, occludin (no CD81) 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2, 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yes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Rectangle 169"/>
          <p:cNvSpPr/>
          <p:nvPr/>
        </p:nvSpPr>
        <p:spPr>
          <a:xfrm>
            <a:off x="1143000" y="4313880"/>
            <a:ext cx="7010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nd = not determined.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, cells were transfected with plasmid expressing EGFP to assess their transfectability after infection. 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, asialoglycoprotein receptor (ASGP-R or Ashwell receptor); in the liver, ASGP-R required for the internalization of HCV materials, including in non-target cells [43], is involved in endocytosis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vi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clathrin-coated pits [70]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and HCV has been reported entering cells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vi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the same path [67-69]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9T18:44:11Z</dcterms:created>
  <dc:creator>triyatnm</dc:creator>
  <dc:description/>
  <dc:language>en-US</dc:language>
  <cp:lastModifiedBy>bertrand saunier</cp:lastModifiedBy>
  <dcterms:modified xsi:type="dcterms:W3CDTF">2011-03-09T23:03:23Z</dcterms:modified>
  <cp:revision>4</cp:revision>
  <dc:subject/>
  <dc:title>Slide 1</dc:title>
</cp:coreProperties>
</file>